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662" userDrawn="1">
          <p15:clr>
            <a:srgbClr val="A4A3A4"/>
          </p15:clr>
        </p15:guide>
        <p15:guide id="2" pos="142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B6FF986-82FF-F59F-CE3C-DD1E56EE4F06}" name="martin.koebel@albertaprecisionlabs.ca" initials="ma" userId="S::urn:spo:guest#martin.koebel@albertaprecisionlabs.ca::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akahashi Kazuaki" initials="TK" lastIdx="8" clrIdx="0"/>
  <p:cmAuthor id="2" name="Saner Flurina" initials="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2CBE2"/>
    <a:srgbClr val="C5AFD4"/>
    <a:srgbClr val="E2ECF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480" autoAdjust="0"/>
    <p:restoredTop sz="96562" autoAdjust="0"/>
  </p:normalViewPr>
  <p:slideViewPr>
    <p:cSldViewPr snapToGrid="0" snapToObjects="1">
      <p:cViewPr>
        <p:scale>
          <a:sx n="186" d="100"/>
          <a:sy n="186" d="100"/>
        </p:scale>
        <p:origin x="544" y="-7344"/>
      </p:cViewPr>
      <p:guideLst>
        <p:guide orient="horz" pos="4662"/>
        <p:guide pos="14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3723A0D-F36C-894A-AF37-B6F6880C4B53}" type="datetimeFigureOut">
              <a:rPr lang="en-US" smtClean="0"/>
              <a:t>5/6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416173-CAE4-5D41-9F10-3306620651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28898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68823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33482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37600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09258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64746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12934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6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549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6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40905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6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98789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6053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840BA-FDC4-264A-9FB4-0EACE76F9AA3}" type="datetimeFigureOut">
              <a:rPr lang="en-US" smtClean="0"/>
              <a:t>5/6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0162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6840BA-FDC4-264A-9FB4-0EACE76F9AA3}" type="datetimeFigureOut">
              <a:rPr lang="en-US" smtClean="0"/>
              <a:t>5/6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DCB595-5369-1947-B290-4ED85832A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05456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89CD804-0F6B-64C4-D546-2F777C9253FE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/>
          <a:stretch/>
        </p:blipFill>
        <p:spPr>
          <a:xfrm>
            <a:off x="64273" y="947530"/>
            <a:ext cx="6729455" cy="672945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87A8492-FF52-DDB4-92AB-954498106148}"/>
              </a:ext>
            </a:extLst>
          </p:cNvPr>
          <p:cNvSpPr txBox="1"/>
          <p:nvPr/>
        </p:nvSpPr>
        <p:spPr>
          <a:xfrm>
            <a:off x="144848" y="7836011"/>
            <a:ext cx="6568303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8. 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Gene alterations across 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RCA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B1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altered subgroups.</a:t>
            </a:r>
            <a:r>
              <a:rPr lang="en-AU" sz="10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roportion of tumors with alterations in genes of interest for each subgroup. WT, wild-type; ALT, altered; HRP, homologous recombination proficient. Genes are ordered by significance using Fisher's exact test;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enjamini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-Hochberg adjusted </a:t>
            </a:r>
            <a:r>
              <a:rPr lang="en-US" sz="10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values are reported.</a:t>
            </a:r>
            <a:endParaRPr lang="en-AU" sz="10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AU" sz="1000" dirty="0"/>
          </a:p>
        </p:txBody>
      </p:sp>
    </p:spTree>
    <p:extLst>
      <p:ext uri="{BB962C8B-B14F-4D97-AF65-F5344CB8AC3E}">
        <p14:creationId xmlns:p14="http://schemas.microsoft.com/office/powerpoint/2010/main" val="39453193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554</TotalTime>
  <Words>57</Words>
  <Application>Microsoft Macintosh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rsed Dale</dc:creator>
  <cp:lastModifiedBy>Dale Garsed</cp:lastModifiedBy>
  <cp:revision>470</cp:revision>
  <dcterms:created xsi:type="dcterms:W3CDTF">2021-08-30T02:59:35Z</dcterms:created>
  <dcterms:modified xsi:type="dcterms:W3CDTF">2024-05-06T07:09:01Z</dcterms:modified>
</cp:coreProperties>
</file>